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0DDFC5-A4C8-45DE-A253-7C9E438466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5EE9C-F6DB-469F-A1A5-11D872CFDE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EE06B-A800-4B2A-AC30-EB7A117C9F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D4DEC-70D4-40D7-B40C-4D0D867C1E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627B3-5C5E-4D64-A96A-E0FEAD9B15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0ECC2-61E3-47F4-890D-F0983D32C3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1DBE7C-019B-426A-AA1A-BE253291FD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B7A16-FCE5-4325-841A-244E39D429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3F1A9-233B-4B85-B5F7-A3CEC997A5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CA048-8430-44A4-9D30-FB733889FF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5E1ED-79CE-43CC-9976-9138962976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B9EEA-259A-49C1-B151-9D3E5D044E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9F3835-0F9B-435E-B94F-53E9A98F0FB9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429440" y="5205240"/>
            <a:ext cx="491760" cy="1654200"/>
            <a:chOff x="4429440" y="5205240"/>
            <a:chExt cx="491760" cy="1654200"/>
          </a:xfrm>
        </p:grpSpPr>
        <p:sp>
          <p:nvSpPr>
            <p:cNvPr id="42" name=""/>
            <p:cNvSpPr/>
            <p:nvPr/>
          </p:nvSpPr>
          <p:spPr>
            <a:xfrm>
              <a:off x="4542120" y="649116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429440" y="52052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849920" y="5535720"/>
              <a:ext cx="71280" cy="7128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H="1" flipV="1">
              <a:off x="4458960" y="6443640"/>
              <a:ext cx="73080" cy="7128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"/>
          <p:cNvGrpSpPr/>
          <p:nvPr/>
        </p:nvGrpSpPr>
        <p:grpSpPr>
          <a:xfrm>
            <a:off x="5461200" y="801720"/>
            <a:ext cx="491760" cy="1653840"/>
            <a:chOff x="5461200" y="801720"/>
            <a:chExt cx="491760" cy="1653840"/>
          </a:xfrm>
        </p:grpSpPr>
        <p:sp>
          <p:nvSpPr>
            <p:cNvPr id="47" name=""/>
            <p:cNvSpPr/>
            <p:nvPr/>
          </p:nvSpPr>
          <p:spPr>
            <a:xfrm>
              <a:off x="5573880" y="208728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461200" y="8017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881680" y="1131840"/>
              <a:ext cx="71280" cy="70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H="1" flipV="1">
              <a:off x="5490720" y="2039400"/>
              <a:ext cx="73080" cy="70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"/>
          <p:cNvGrpSpPr/>
          <p:nvPr/>
        </p:nvGrpSpPr>
        <p:grpSpPr>
          <a:xfrm>
            <a:off x="1057320" y="801720"/>
            <a:ext cx="491760" cy="1653840"/>
            <a:chOff x="1057320" y="801720"/>
            <a:chExt cx="491760" cy="1653840"/>
          </a:xfrm>
        </p:grpSpPr>
        <p:sp>
          <p:nvSpPr>
            <p:cNvPr id="52" name=""/>
            <p:cNvSpPr/>
            <p:nvPr/>
          </p:nvSpPr>
          <p:spPr>
            <a:xfrm>
              <a:off x="1170000" y="208728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057320" y="8017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477800" y="1131840"/>
              <a:ext cx="71280" cy="70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 flipV="1">
              <a:off x="1086840" y="2039400"/>
              <a:ext cx="73080" cy="7092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"/>
          <p:cNvSpPr/>
          <p:nvPr/>
        </p:nvSpPr>
        <p:spPr>
          <a:xfrm>
            <a:off x="723600" y="549360"/>
            <a:ext cx="1463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gChromo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901800" y="5734080"/>
            <a:ext cx="128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gMORN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997440" y="54936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97800" y="5734080"/>
            <a:ext cx="85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520" y="649116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rcRect l="4108" t="12324" r="4108" b="12324"/>
          <a:stretch/>
        </p:blipFill>
        <p:spPr>
          <a:xfrm>
            <a:off x="3132000" y="3357720"/>
            <a:ext cx="2811600" cy="23097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"/>
          <a:srcRect l="4108" t="12324" r="4108" b="12324"/>
          <a:stretch/>
        </p:blipFill>
        <p:spPr>
          <a:xfrm>
            <a:off x="179280" y="3357720"/>
            <a:ext cx="2811600" cy="230976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3"/>
          <a:srcRect l="4108" t="12324" r="4108" b="12324"/>
          <a:stretch/>
        </p:blipFill>
        <p:spPr>
          <a:xfrm>
            <a:off x="179280" y="981000"/>
            <a:ext cx="2808360" cy="230688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4"/>
          <a:srcRect l="4108" t="12324" r="4108" b="12324"/>
          <a:stretch/>
        </p:blipFill>
        <p:spPr>
          <a:xfrm>
            <a:off x="3132000" y="981000"/>
            <a:ext cx="2811600" cy="230976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5"/>
          <a:srcRect l="4108" t="12324" r="4108" b="12324"/>
          <a:stretch/>
        </p:blipFill>
        <p:spPr>
          <a:xfrm>
            <a:off x="6081840" y="2205000"/>
            <a:ext cx="2811240" cy="230976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6199560" y="2521080"/>
            <a:ext cx="111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ffffff"/>
                </a:solidFill>
                <a:latin typeface="Arial"/>
              </a:rPr>
              <a:t>Budd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732720" y="2924280"/>
            <a:ext cx="0" cy="730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597440" y="24210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ffffff"/>
                </a:solidFill>
                <a:latin typeface="Arial"/>
              </a:rPr>
              <a:t>Mito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101080" y="2851200"/>
            <a:ext cx="0" cy="730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"/>
          <p:cNvGrpSpPr/>
          <p:nvPr/>
        </p:nvGrpSpPr>
        <p:grpSpPr>
          <a:xfrm>
            <a:off x="3204000" y="3500280"/>
            <a:ext cx="2366640" cy="576360"/>
            <a:chOff x="3204000" y="3500280"/>
            <a:chExt cx="2366640" cy="576360"/>
          </a:xfrm>
        </p:grpSpPr>
        <p:sp>
          <p:nvSpPr>
            <p:cNvPr id="71" name=""/>
            <p:cNvSpPr/>
            <p:nvPr/>
          </p:nvSpPr>
          <p:spPr>
            <a:xfrm>
              <a:off x="3204000" y="3600360"/>
              <a:ext cx="1110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Budd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737160" y="400356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601880" y="3500280"/>
              <a:ext cx="96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Mitosi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105520" y="393048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"/>
          <p:cNvGrpSpPr/>
          <p:nvPr/>
        </p:nvGrpSpPr>
        <p:grpSpPr>
          <a:xfrm>
            <a:off x="3204000" y="1125360"/>
            <a:ext cx="2366640" cy="576360"/>
            <a:chOff x="3204000" y="1125360"/>
            <a:chExt cx="2366640" cy="576360"/>
          </a:xfrm>
        </p:grpSpPr>
        <p:sp>
          <p:nvSpPr>
            <p:cNvPr id="76" name=""/>
            <p:cNvSpPr/>
            <p:nvPr/>
          </p:nvSpPr>
          <p:spPr>
            <a:xfrm>
              <a:off x="3204000" y="1225440"/>
              <a:ext cx="1110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Budd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737160" y="162864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601880" y="1125360"/>
              <a:ext cx="96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Mitosi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105520" y="155556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"/>
          <p:cNvGrpSpPr/>
          <p:nvPr/>
        </p:nvGrpSpPr>
        <p:grpSpPr>
          <a:xfrm>
            <a:off x="395640" y="3500280"/>
            <a:ext cx="2366640" cy="576360"/>
            <a:chOff x="395640" y="3500280"/>
            <a:chExt cx="2366640" cy="576360"/>
          </a:xfrm>
        </p:grpSpPr>
        <p:sp>
          <p:nvSpPr>
            <p:cNvPr id="81" name=""/>
            <p:cNvSpPr/>
            <p:nvPr/>
          </p:nvSpPr>
          <p:spPr>
            <a:xfrm>
              <a:off x="395640" y="3600360"/>
              <a:ext cx="1110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Budd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928800" y="400356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793520" y="3500280"/>
              <a:ext cx="96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Mitosi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297160" y="393048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"/>
          <p:cNvGrpSpPr/>
          <p:nvPr/>
        </p:nvGrpSpPr>
        <p:grpSpPr>
          <a:xfrm>
            <a:off x="395640" y="1125360"/>
            <a:ext cx="2366640" cy="576360"/>
            <a:chOff x="395640" y="1125360"/>
            <a:chExt cx="2366640" cy="576360"/>
          </a:xfrm>
        </p:grpSpPr>
        <p:sp>
          <p:nvSpPr>
            <p:cNvPr id="86" name=""/>
            <p:cNvSpPr/>
            <p:nvPr/>
          </p:nvSpPr>
          <p:spPr>
            <a:xfrm>
              <a:off x="395640" y="1225440"/>
              <a:ext cx="1110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Budd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928800" y="162864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793520" y="1125360"/>
              <a:ext cx="96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ffffff"/>
                  </a:solidFill>
                  <a:latin typeface="Arial"/>
                </a:rPr>
                <a:t>Mitosi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97160" y="1555560"/>
              <a:ext cx="0" cy="7308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"/>
          <p:cNvSpPr/>
          <p:nvPr/>
        </p:nvSpPr>
        <p:spPr>
          <a:xfrm>
            <a:off x="6568200" y="1787400"/>
            <a:ext cx="181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Phase contra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5T10:09:28Z</dcterms:created>
  <dc:creator>Mathieu Gissot</dc:creator>
  <dc:description/>
  <dc:language>en-US</dc:language>
  <cp:lastModifiedBy>Stan</cp:lastModifiedBy>
  <dcterms:modified xsi:type="dcterms:W3CDTF">2012-02-06T16:03:13Z</dcterms:modified>
  <cp:revision>8</cp:revision>
  <dc:subject/>
  <dc:title>Diapositive 1</dc:title>
</cp:coreProperties>
</file>